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96800365775615"/>
          <c:y val="0.15919919687556836"/>
          <c:w val="0.77042693187337363"/>
          <c:h val="0.570876449022179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2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DMSO</c:v>
                </c:pt>
                <c:pt idx="1">
                  <c:v>Ku55933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0.9</c:v>
                </c:pt>
                <c:pt idx="1">
                  <c:v>0.3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Ctrl s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2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DMSO</c:v>
                </c:pt>
                <c:pt idx="1">
                  <c:v>Ku55933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>
                  <c:v>0.8</c:v>
                </c:pt>
                <c:pt idx="1">
                  <c:v>0.2</c:v>
                </c:pt>
              </c:numCache>
            </c:numRef>
          </c:val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CX3CR1 s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2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DMSO</c:v>
                </c:pt>
                <c:pt idx="1">
                  <c:v>Ku55933</c:v>
                </c:pt>
              </c:strCache>
            </c:strRef>
          </c:cat>
          <c:val>
            <c:numRef>
              <c:f>Sheet1!$B$4:$C$4</c:f>
              <c:numCache>
                <c:formatCode>General</c:formatCode>
                <c:ptCount val="2"/>
                <c:pt idx="0">
                  <c:v>0.38</c:v>
                </c:pt>
                <c:pt idx="1">
                  <c:v>0.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192480"/>
        <c:axId val="156196960"/>
      </c:barChart>
      <c:catAx>
        <c:axId val="15619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196960"/>
        <c:crosses val="autoZero"/>
        <c:auto val="1"/>
        <c:lblAlgn val="ctr"/>
        <c:lblOffset val="100"/>
        <c:noMultiLvlLbl val="0"/>
      </c:catAx>
      <c:valAx>
        <c:axId val="156196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atio pATM/ATM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192480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2449027167713079"/>
          <c:y val="3.997733734097849E-2"/>
          <c:w val="0.67905257798864016"/>
          <c:h val="0.129647998889601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184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291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397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370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995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400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802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096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429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014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705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90AF5-609B-4949-ABE3-3501F996FBF2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6C5236-8EBB-4DBC-8252-8D0387AD4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436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chart" Target="../charts/chart1.xml"/><Relationship Id="rId3" Type="http://schemas.openxmlformats.org/officeDocument/2006/relationships/image" Target="../media/image2.png"/><Relationship Id="rId21" Type="http://schemas.microsoft.com/office/2007/relationships/hdphoto" Target="../media/hdphoto2.wdp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microsoft.com/office/2007/relationships/hdphoto" Target="../media/hdphoto4.wdp"/><Relationship Id="rId2" Type="http://schemas.openxmlformats.org/officeDocument/2006/relationships/image" Target="../media/image1.emf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24" Type="http://schemas.openxmlformats.org/officeDocument/2006/relationships/image" Target="../media/image20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23" Type="http://schemas.microsoft.com/office/2007/relationships/hdphoto" Target="../media/hdphoto3.wdp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microsoft.com/office/2007/relationships/hdphoto" Target="../media/hdphoto1.wdp"/><Relationship Id="rId14" Type="http://schemas.openxmlformats.org/officeDocument/2006/relationships/image" Target="../media/image12.png"/><Relationship Id="rId22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5435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ie et al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1178729"/>
              </p:ext>
            </p:extLst>
          </p:nvPr>
        </p:nvGraphicFramePr>
        <p:xfrm>
          <a:off x="50799" y="3811159"/>
          <a:ext cx="6739467" cy="124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334"/>
                <a:gridCol w="1405467"/>
                <a:gridCol w="1354667"/>
                <a:gridCol w="1523999"/>
              </a:tblGrid>
              <a:tr h="301228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rison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2</a:t>
                      </a:r>
                      <a:r>
                        <a:rPr lang="en-US" sz="10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SF2</a:t>
                      </a:r>
                      <a:r>
                        <a:rPr lang="en-US" sz="10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t</a:t>
                      </a:r>
                    </a:p>
                    <a:p>
                      <a:pPr algn="ctr"/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10</a:t>
                      </a:r>
                      <a:r>
                        <a:rPr lang="en-US" sz="10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D10</a:t>
                      </a:r>
                      <a:r>
                        <a:rPr lang="en-US" sz="10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t</a:t>
                      </a:r>
                      <a:endParaRPr lang="en-US" sz="1000" baseline="-25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osensitization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8191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SO </a:t>
                      </a:r>
                      <a:r>
                        <a:rPr lang="en-US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u5593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8191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 </a:t>
                      </a:r>
                      <a:r>
                        <a:rPr lang="en-US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X</a:t>
                      </a:r>
                      <a:r>
                        <a:rPr lang="en-US" sz="10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1 siRNA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8191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 </a:t>
                      </a:r>
                      <a:r>
                        <a:rPr lang="en-US" sz="10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X</a:t>
                      </a:r>
                      <a:r>
                        <a:rPr lang="en-US" sz="1000" baseline="-25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1 siRNA + Ku55933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0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2954448" y="799935"/>
            <a:ext cx="3866957" cy="2839739"/>
            <a:chOff x="5309807" y="1266635"/>
            <a:chExt cx="5372572" cy="3945407"/>
          </a:xfrm>
        </p:grpSpPr>
        <p:pic>
          <p:nvPicPr>
            <p:cNvPr id="16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3" t="9349" r="6795" b="35326"/>
            <a:stretch/>
          </p:blipFill>
          <p:spPr bwMode="auto">
            <a:xfrm>
              <a:off x="5982162" y="1315965"/>
              <a:ext cx="4700217" cy="33792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TextBox 16"/>
            <p:cNvSpPr txBox="1"/>
            <p:nvPr/>
          </p:nvSpPr>
          <p:spPr>
            <a:xfrm>
              <a:off x="6155879" y="3365663"/>
              <a:ext cx="2989098" cy="12105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●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1000"/>
                </a:lnSpc>
              </a:pP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○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 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1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▼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Ku55933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si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  <a:sym typeface="Webdings" panose="05030102010509060703" pitchFamily="18" charset="2"/>
              </a:endParaRPr>
            </a:p>
            <a:p>
              <a:pPr>
                <a:lnSpc>
                  <a:spcPts val="1000"/>
                </a:lnSpc>
              </a:pP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Δ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 Ku55933 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  <a:sym typeface="Webdings" panose="05030102010509060703" pitchFamily="18" charset="2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309807" y="1266635"/>
              <a:ext cx="812207" cy="3549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4373370" y="3033477"/>
              <a:ext cx="2752896" cy="4924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viving Fract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932439" y="4656147"/>
              <a:ext cx="4663686" cy="555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       1                         2                         3</a:t>
              </a:r>
            </a:p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x-ray radiation, gray</a:t>
              </a:r>
            </a:p>
          </p:txBody>
        </p:sp>
        <p:sp>
          <p:nvSpPr>
            <p:cNvPr id="21" name="Right Bracket 20"/>
            <p:cNvSpPr/>
            <p:nvPr/>
          </p:nvSpPr>
          <p:spPr>
            <a:xfrm>
              <a:off x="10058400" y="3164613"/>
              <a:ext cx="45719" cy="579978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ight Bracket 21"/>
            <p:cNvSpPr/>
            <p:nvPr/>
          </p:nvSpPr>
          <p:spPr>
            <a:xfrm>
              <a:off x="10180319" y="2159900"/>
              <a:ext cx="87086" cy="1185846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223860" y="2606404"/>
              <a:ext cx="2952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6609" y="17844"/>
            <a:ext cx="3101241" cy="3973755"/>
            <a:chOff x="127842" y="528188"/>
            <a:chExt cx="2171594" cy="2782531"/>
          </a:xfrm>
        </p:grpSpPr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7227" y="1071993"/>
              <a:ext cx="440429" cy="422687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6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7227" y="1494680"/>
              <a:ext cx="440429" cy="428551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7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7656" y="1071993"/>
              <a:ext cx="432933" cy="422687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8" name="Picture 5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7656" y="1494681"/>
              <a:ext cx="432933" cy="428550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9" name="Picture 6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3016" y="1071994"/>
              <a:ext cx="431699" cy="422687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0" name="Picture 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3016" y="1494681"/>
              <a:ext cx="431699" cy="428550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1" name="Picture 8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4716" y="1071993"/>
              <a:ext cx="435084" cy="422687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2" name="Picture 9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4715" y="1494681"/>
              <a:ext cx="435084" cy="428550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3" name="Picture 10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7228" y="1923231"/>
              <a:ext cx="440429" cy="426158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4" name="Picture 11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7227" y="2349760"/>
              <a:ext cx="440429" cy="427134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5" name="Picture 12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7656" y="1923231"/>
              <a:ext cx="432933" cy="426529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6" name="Picture 13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7656" y="2349760"/>
              <a:ext cx="432933" cy="427134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7" name="Picture 14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3016" y="1923231"/>
              <a:ext cx="431699" cy="426529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8" name="Picture 15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3017" y="2349389"/>
              <a:ext cx="431699" cy="427505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9" name="Picture 16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4716" y="1923232"/>
              <a:ext cx="435084" cy="426528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0" name="Picture 17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4716" y="2349389"/>
              <a:ext cx="435084" cy="427505"/>
            </a:xfrm>
            <a:prstGeom prst="ellipse">
              <a:avLst/>
            </a:prstGeom>
            <a:ln w="9525">
              <a:noFill/>
              <a:miter lim="800000"/>
              <a:headEnd/>
              <a:tailEnd/>
            </a:ln>
            <a:effectLst>
              <a:outerShdw blurRad="381000" dist="292100" dir="5400000" sx="-80000" sy="-18000" rotWithShape="0">
                <a:srgbClr val="000000">
                  <a:alpha val="22000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1" name="TextBox 40"/>
            <p:cNvSpPr txBox="1"/>
            <p:nvPr/>
          </p:nvSpPr>
          <p:spPr>
            <a:xfrm rot="16200000">
              <a:off x="-1123338" y="1779368"/>
              <a:ext cx="2782531" cy="280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u55933            DMSO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si  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rl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si  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81557" y="2795583"/>
              <a:ext cx="2017879" cy="4956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       1                2                 3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</a:t>
              </a:r>
            </a:p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000" dirty="0"/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0" y="259403"/>
            <a:ext cx="327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" y="5572364"/>
            <a:ext cx="327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" name="Group 44"/>
          <p:cNvGrpSpPr>
            <a:grpSpLocks noChangeAspect="1"/>
          </p:cNvGrpSpPr>
          <p:nvPr/>
        </p:nvGrpSpPr>
        <p:grpSpPr>
          <a:xfrm>
            <a:off x="956235" y="6367036"/>
            <a:ext cx="1162812" cy="576719"/>
            <a:chOff x="380503" y="11870366"/>
            <a:chExt cx="2270072" cy="1125886"/>
          </a:xfrm>
        </p:grpSpPr>
        <p:pic>
          <p:nvPicPr>
            <p:cNvPr id="46" name="Picture 3"/>
            <p:cNvPicPr preferRelativeResize="0">
              <a:picLocks noChangeArrowheads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0503" y="12639636"/>
              <a:ext cx="2267712" cy="35661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7" name="Picture 2"/>
            <p:cNvPicPr preferRelativeResize="0">
              <a:picLocks noChangeArrowheads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contrast="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863" y="11870366"/>
              <a:ext cx="2267712" cy="35661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8" name="Picture 4" descr="C:\Users\jxie8\Desktop\total ATM.jpg"/>
            <p:cNvPicPr preferRelativeResize="0">
              <a:picLocks noChangeArrowheads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4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625" y="12255862"/>
              <a:ext cx="2267712" cy="35661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9" name="TextBox 48"/>
          <p:cNvSpPr txBox="1"/>
          <p:nvPr/>
        </p:nvSpPr>
        <p:spPr>
          <a:xfrm>
            <a:off x="2047327" y="6318280"/>
            <a:ext cx="10099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TM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047327" y="6539682"/>
            <a:ext cx="1162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otal ATM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047327" y="6729308"/>
            <a:ext cx="1162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-tubul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8538241">
            <a:off x="835512" y="5936658"/>
            <a:ext cx="826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907958" y="7014550"/>
            <a:ext cx="6643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356263" y="7009329"/>
            <a:ext cx="8883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Ku5593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8538241">
            <a:off x="1008635" y="5946183"/>
            <a:ext cx="826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rl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8538241">
            <a:off x="1194653" y="5955708"/>
            <a:ext cx="826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R1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8538241">
            <a:off x="1410365" y="5936658"/>
            <a:ext cx="826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538241">
            <a:off x="1556607" y="5946183"/>
            <a:ext cx="826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rl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8538241">
            <a:off x="1769510" y="5955708"/>
            <a:ext cx="826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R1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0" name="Chart 59"/>
          <p:cNvGraphicFramePr/>
          <p:nvPr>
            <p:extLst>
              <p:ext uri="{D42A27DB-BD31-4B8C-83A1-F6EECF244321}">
                <p14:modId xmlns:p14="http://schemas.microsoft.com/office/powerpoint/2010/main" val="1112051224"/>
              </p:ext>
            </p:extLst>
          </p:nvPr>
        </p:nvGraphicFramePr>
        <p:xfrm>
          <a:off x="3053689" y="5713971"/>
          <a:ext cx="2659554" cy="1671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sp>
        <p:nvSpPr>
          <p:cNvPr id="61" name="Right Bracket 60"/>
          <p:cNvSpPr/>
          <p:nvPr/>
        </p:nvSpPr>
        <p:spPr>
          <a:xfrm rot="16200000">
            <a:off x="4255440" y="6230003"/>
            <a:ext cx="45719" cy="15771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ight Bracket 61"/>
          <p:cNvSpPr/>
          <p:nvPr/>
        </p:nvSpPr>
        <p:spPr>
          <a:xfrm rot="16200000">
            <a:off x="4431966" y="5750499"/>
            <a:ext cx="45719" cy="9424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ight Bracket 62"/>
          <p:cNvSpPr/>
          <p:nvPr/>
        </p:nvSpPr>
        <p:spPr>
          <a:xfrm rot="16200000">
            <a:off x="4882404" y="5594400"/>
            <a:ext cx="45719" cy="9424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ight Bracket 63"/>
          <p:cNvSpPr/>
          <p:nvPr/>
        </p:nvSpPr>
        <p:spPr>
          <a:xfrm rot="16200000">
            <a:off x="4647817" y="5672144"/>
            <a:ext cx="45719" cy="9424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4211983" y="6150570"/>
            <a:ext cx="131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360825" y="6068142"/>
            <a:ext cx="131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624117" y="5993424"/>
            <a:ext cx="131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830481" y="5915148"/>
            <a:ext cx="131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ight Bracket 68"/>
          <p:cNvSpPr/>
          <p:nvPr/>
        </p:nvSpPr>
        <p:spPr>
          <a:xfrm rot="16200000">
            <a:off x="5274781" y="6672213"/>
            <a:ext cx="45719" cy="15771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Box 69"/>
          <p:cNvSpPr txBox="1"/>
          <p:nvPr/>
        </p:nvSpPr>
        <p:spPr>
          <a:xfrm>
            <a:off x="5228977" y="6594726"/>
            <a:ext cx="131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Left Bracket 2"/>
          <p:cNvSpPr/>
          <p:nvPr/>
        </p:nvSpPr>
        <p:spPr>
          <a:xfrm rot="16200000">
            <a:off x="1180825" y="6723807"/>
            <a:ext cx="107885" cy="557063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Left Bracket 70"/>
          <p:cNvSpPr/>
          <p:nvPr/>
        </p:nvSpPr>
        <p:spPr>
          <a:xfrm rot="16200000">
            <a:off x="1746178" y="6721351"/>
            <a:ext cx="107885" cy="557063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443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04</Words>
  <Application>Microsoft Office PowerPoint</Application>
  <PresentationFormat>On-screen Show 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Web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6</cp:revision>
  <dcterms:created xsi:type="dcterms:W3CDTF">2016-11-11T07:07:29Z</dcterms:created>
  <dcterms:modified xsi:type="dcterms:W3CDTF">2018-02-12T16:25:05Z</dcterms:modified>
</cp:coreProperties>
</file>